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1" r:id="rId4"/>
    <p:sldId id="260" r:id="rId5"/>
    <p:sldId id="264" r:id="rId6"/>
    <p:sldId id="263" r:id="rId7"/>
    <p:sldId id="266" r:id="rId8"/>
    <p:sldId id="26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25368" autoAdjust="0"/>
    <p:restoredTop sz="94660"/>
  </p:normalViewPr>
  <p:slideViewPr>
    <p:cSldViewPr snapToGrid="0">
      <p:cViewPr>
        <p:scale>
          <a:sx n="100" d="100"/>
          <a:sy n="100" d="100"/>
        </p:scale>
        <p:origin x="-660" y="-2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1082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28262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00568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00877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09265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87036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3362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546859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6488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39807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33246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431B87-1B84-4B7C-BB10-85DFA4853014}" type="datetimeFigureOut">
              <a:rPr lang="en-US" smtClean="0"/>
              <a:pPr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BF102-5BA3-4C58-9C9F-26167908A2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98509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31808" t="19712" r="33272" b="9409"/>
          <a:stretch/>
        </p:blipFill>
        <p:spPr>
          <a:xfrm>
            <a:off x="6071137" y="187631"/>
            <a:ext cx="2961501" cy="2958584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 xmlns="">
                  <a14:imgLayer r:embed="rId5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32963" t="19731" r="35731" b="12737"/>
          <a:stretch/>
        </p:blipFill>
        <p:spPr>
          <a:xfrm>
            <a:off x="2362581" y="3202542"/>
            <a:ext cx="3194906" cy="3496153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 xmlns="">
                  <a14:imgLayer r:embed="rId7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25828" t="21528" r="34134" b="12138"/>
          <a:stretch/>
        </p:blipFill>
        <p:spPr>
          <a:xfrm>
            <a:off x="-413939" y="3425203"/>
            <a:ext cx="3180836" cy="3365347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 xmlns="">
                  <a14:imgLayer r:embed="rId9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27856" t="19506" r="29758" b="3434"/>
          <a:stretch/>
        </p:blipFill>
        <p:spPr>
          <a:xfrm>
            <a:off x="8733308" y="129505"/>
            <a:ext cx="3486151" cy="3499365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 xmlns="">
                  <a14:imgLayer r:embed="rId11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34122" t="20130" r="35636" b="17739"/>
          <a:stretch/>
        </p:blipFill>
        <p:spPr>
          <a:xfrm>
            <a:off x="5285688" y="3162396"/>
            <a:ext cx="3551410" cy="349615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 xmlns="">
                  <a14:imgLayer r:embed="rId1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31149" t="20742" r="33273" b="13942"/>
          <a:stretch/>
        </p:blipFill>
        <p:spPr>
          <a:xfrm>
            <a:off x="-500836" y="0"/>
            <a:ext cx="3856283" cy="3486149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5255501" y="6527245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1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14"/>
          <a:srcRect l="35871" t="18888" r="36347" b="37431"/>
          <a:stretch/>
        </p:blipFill>
        <p:spPr>
          <a:xfrm>
            <a:off x="3048774" y="57686"/>
            <a:ext cx="3371850" cy="3143250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TextBox 8"/>
          <p:cNvSpPr txBox="1"/>
          <p:nvPr/>
        </p:nvSpPr>
        <p:spPr>
          <a:xfrm>
            <a:off x="1923404" y="2760701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44717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57499" y="2851677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44095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973961" y="2851677"/>
            <a:ext cx="925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Q57498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699102" y="2760701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45267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72144" y="6527245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44782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329183" y="6428304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44197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568347" y="6488668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44093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 xmlns="">
                  <a14:imgLayer r:embed="rId16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7423" t="2905" r="9274" b="2489"/>
          <a:stretch/>
        </p:blipFill>
        <p:spPr>
          <a:xfrm>
            <a:off x="9116592" y="3628870"/>
            <a:ext cx="2941981" cy="322913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1061233" y="6428304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44720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0195017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4977" y="297098"/>
            <a:ext cx="6709144" cy="626380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/>
          <p:cNvSpPr txBox="1"/>
          <p:nvPr/>
        </p:nvSpPr>
        <p:spPr>
          <a:xfrm>
            <a:off x="5669189" y="6488668"/>
            <a:ext cx="1302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2A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>
            <a:off x="4957687" y="5762856"/>
            <a:ext cx="1" cy="592567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4947054" y="5762855"/>
            <a:ext cx="27432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5227007" y="5762856"/>
            <a:ext cx="0" cy="592567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4957687" y="6355423"/>
            <a:ext cx="27432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39202473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3688" y="0"/>
            <a:ext cx="6439412" cy="6128363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/>
          <p:cNvSpPr txBox="1"/>
          <p:nvPr/>
        </p:nvSpPr>
        <p:spPr>
          <a:xfrm>
            <a:off x="5428314" y="6326743"/>
            <a:ext cx="1347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2 B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>
            <a:off x="6437987" y="5490705"/>
            <a:ext cx="6590" cy="53951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6444577" y="5490705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6541477" y="5490705"/>
            <a:ext cx="0" cy="53951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6451874" y="6030217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7164236" y="5455011"/>
            <a:ext cx="6590" cy="57520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7161301" y="5455011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7261024" y="5455011"/>
            <a:ext cx="111" cy="57520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7163617" y="6030217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3194277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2737" y="297097"/>
            <a:ext cx="6486526" cy="626380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/>
          <p:cNvSpPr txBox="1"/>
          <p:nvPr/>
        </p:nvSpPr>
        <p:spPr>
          <a:xfrm>
            <a:off x="5345482" y="6376236"/>
            <a:ext cx="1360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2 C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>
            <a:off x="6472220" y="3066910"/>
            <a:ext cx="6590" cy="53951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6459760" y="3066910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6556660" y="3066910"/>
            <a:ext cx="0" cy="53951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6476582" y="3606422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22544120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429772" y="6269593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3095113" y="938462"/>
            <a:ext cx="5944624" cy="4805113"/>
            <a:chOff x="3114163" y="128837"/>
            <a:chExt cx="5944624" cy="480511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rcRect b="39960"/>
            <a:stretch>
              <a:fillRect/>
            </a:stretch>
          </p:blipFill>
          <p:spPr>
            <a:xfrm>
              <a:off x="3114163" y="128837"/>
              <a:ext cx="5944624" cy="4805113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5" name="Straight Connector 4"/>
            <p:cNvCxnSpPr/>
            <p:nvPr/>
          </p:nvCxnSpPr>
          <p:spPr>
            <a:xfrm flipH="1">
              <a:off x="4926298" y="290761"/>
              <a:ext cx="1" cy="785564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>
              <a:off x="4926299" y="290762"/>
              <a:ext cx="160639" cy="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5086938" y="290762"/>
              <a:ext cx="0" cy="785563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4926298" y="1076325"/>
              <a:ext cx="16064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5278714" y="1482312"/>
              <a:ext cx="6590" cy="860316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 flipV="1">
              <a:off x="5278714" y="1482311"/>
              <a:ext cx="91440" cy="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H="1">
              <a:off x="5381496" y="1482312"/>
              <a:ext cx="1" cy="860316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V="1">
              <a:off x="5285304" y="2342628"/>
              <a:ext cx="91440" cy="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 flipH="1">
              <a:off x="6694556" y="2798799"/>
              <a:ext cx="1" cy="77393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6694557" y="2798799"/>
              <a:ext cx="9144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6788520" y="2798799"/>
              <a:ext cx="0" cy="77393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6698919" y="3572729"/>
              <a:ext cx="9144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6449191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4474" y="1820449"/>
            <a:ext cx="7130702" cy="2894426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/>
          <p:cNvSpPr txBox="1"/>
          <p:nvPr/>
        </p:nvSpPr>
        <p:spPr>
          <a:xfrm>
            <a:off x="5334522" y="5440918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4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8826721" y="1931096"/>
            <a:ext cx="6590" cy="82296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8824355" y="1931096"/>
            <a:ext cx="13716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8954423" y="1931096"/>
            <a:ext cx="0" cy="82296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8833311" y="2750607"/>
            <a:ext cx="13716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7930262" y="2987066"/>
            <a:ext cx="0" cy="64008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7930262" y="2987066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8041849" y="2993710"/>
            <a:ext cx="0" cy="64008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7942722" y="3626676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2288536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5538" y="958763"/>
            <a:ext cx="7400925" cy="437197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/>
          <p:cNvSpPr txBox="1"/>
          <p:nvPr/>
        </p:nvSpPr>
        <p:spPr>
          <a:xfrm>
            <a:off x="5771759" y="5755412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8684106" y="1149383"/>
            <a:ext cx="0" cy="64008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8690696" y="1149383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>
            <a:off x="8794185" y="1149383"/>
            <a:ext cx="0" cy="64008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8684106" y="1787538"/>
            <a:ext cx="10972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798695" y="2064716"/>
            <a:ext cx="0" cy="64008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786235" y="2064716"/>
            <a:ext cx="13716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H="1">
            <a:off x="3918299" y="2064716"/>
            <a:ext cx="0" cy="64008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3789170" y="2712396"/>
            <a:ext cx="13716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996722" y="2064716"/>
            <a:ext cx="0" cy="64008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4003312" y="2064716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H="1">
            <a:off x="4087751" y="2064716"/>
            <a:ext cx="0" cy="64008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3996722" y="2712396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34120163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534025" y="6281738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6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rcRect b="24069"/>
          <a:stretch>
            <a:fillRect/>
          </a:stretch>
        </p:blipFill>
        <p:spPr>
          <a:xfrm>
            <a:off x="3123688" y="-1"/>
            <a:ext cx="5944624" cy="6076951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4" name="Straight Connector 3"/>
          <p:cNvCxnSpPr/>
          <p:nvPr/>
        </p:nvCxnSpPr>
        <p:spPr>
          <a:xfrm>
            <a:off x="8482516" y="5223363"/>
            <a:ext cx="0" cy="752455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8489106" y="5223363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8573545" y="5223363"/>
            <a:ext cx="8135" cy="752455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8482516" y="5975818"/>
            <a:ext cx="9144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34271017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1</TotalTime>
  <Words>26</Words>
  <Application>Microsoft Office PowerPoint</Application>
  <PresentationFormat>Custom</PresentationFormat>
  <Paragraphs>16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bby</dc:creator>
  <cp:lastModifiedBy>HP</cp:lastModifiedBy>
  <cp:revision>54</cp:revision>
  <dcterms:created xsi:type="dcterms:W3CDTF">2013-08-15T18:02:53Z</dcterms:created>
  <dcterms:modified xsi:type="dcterms:W3CDTF">2014-05-20T12:08:02Z</dcterms:modified>
</cp:coreProperties>
</file>